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47A30-DCE9-4C5A-BB8C-878D6DB21F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BA8BD-EBD9-42D7-8E5A-D6318FE06B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30E5E-8BA1-4143-AB67-9D2D56C8C5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B04A1-A457-42C9-BA11-79FE80442A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FE8E0-F5EF-4D96-AC05-C98AEB0AFC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AD931-756C-452C-BFE7-41DA0EC282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E3583-6264-4802-BC0B-DAD86C33E1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1ABEE-94EC-4226-B720-86964CAD4E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73549C-7A22-48F9-AE2D-C21953FBE0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A9A0B-8EE0-44F6-974E-54ABFAB4D4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06C1F-79E2-4A6C-B057-0825EA7892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710D4-3309-468D-8AE8-36860395DD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2E86A0-3D7A-4648-B9D6-3C2A3C13077A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A. Summary results for the HRs computed during the cross-validation procedure. Whole datase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50920" y="1052640"/>
          <a:ext cx="8640720" cy="5140080"/>
        </p:xfrm>
        <a:graphic>
          <a:graphicData uri="http://schemas.openxmlformats.org/drawingml/2006/table">
            <a:tbl>
              <a:tblPr/>
              <a:tblGrid>
                <a:gridCol w="595080"/>
                <a:gridCol w="1368720"/>
                <a:gridCol w="1653840"/>
                <a:gridCol w="1675080"/>
                <a:gridCol w="1673280"/>
                <a:gridCol w="1674720"/>
              </a:tblGrid>
              <a:tr h="4316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aining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id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207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GF1R-alpha and IGF2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GFR and IGF1R-alpha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GF1R-alpha and IGF2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GFR and IGF1R-alpha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 rowSpan="5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F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75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78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2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di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76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1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75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0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21-1.12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43-1.056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74-1.139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65-1.18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RQ* Rang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56-0.86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736-0.886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51-0.89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744-0.89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oss 1 %**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5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9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1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 rowSpan="5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2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di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1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8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0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5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355-1.17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38-1.10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05-1.36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16-1.07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RQ* Rang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81-0.94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83-0.87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76-0.957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63-0.857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oss 1 %**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6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7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5 - TextBox"/>
          <p:cNvSpPr/>
          <p:nvPr/>
        </p:nvSpPr>
        <p:spPr>
          <a:xfrm>
            <a:off x="179280" y="6308640"/>
            <a:ext cx="7535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IRQ: Inter-quarti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Percent of replications where the upper or lower limit of the 95% CI of HR crosses 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B. Summary results for the HRs computed during the cross-validation procedure. Luminal A and B cohor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250920" y="1052640"/>
          <a:ext cx="8640720" cy="5140080"/>
        </p:xfrm>
        <a:graphic>
          <a:graphicData uri="http://schemas.openxmlformats.org/drawingml/2006/table">
            <a:tbl>
              <a:tblPr/>
              <a:tblGrid>
                <a:gridCol w="595080"/>
                <a:gridCol w="1349640"/>
                <a:gridCol w="1672920"/>
                <a:gridCol w="1675080"/>
                <a:gridCol w="1673280"/>
                <a:gridCol w="1674720"/>
              </a:tblGrid>
              <a:tr h="4316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aining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id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203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GF1R-alpha and IGF2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GFR and IGF1R-alpha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GF1R-alpha and IGF2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GFR and IGF1R-alpha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120">
                <a:tc rowSpan="5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F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4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1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7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4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di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5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1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4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83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273-1.089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78-1.13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34-1.06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59-1.299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RQ* Rang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47-0.75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735-0.89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41-0.773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754-0.933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oss 1 %**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6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5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 rowSpan="5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56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9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57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70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dia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57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8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54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600" spc="-1" strike="noStrike">
                          <a:solidFill>
                            <a:srgbClr val="000000"/>
                          </a:solidFill>
                          <a:latin typeface="Calibri"/>
                          <a:ea typeface="ITC Bookman"/>
                        </a:rPr>
                        <a:t>0.69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1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267-0.881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69-1.01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306-0.953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27-1.016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RQ* Rang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63-0.656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597-0.76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463-0.674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0.628-0.787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9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oss 1 %**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1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2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5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5 - TextBox"/>
          <p:cNvSpPr/>
          <p:nvPr/>
        </p:nvSpPr>
        <p:spPr>
          <a:xfrm>
            <a:off x="179280" y="6308640"/>
            <a:ext cx="7535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IRQ: Inter-quarti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Percent of replications where the upper or lower limit of the 95% CI of HR crosses 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8T15:31:11Z</dcterms:created>
  <dc:creator>Ζωή Αλεξοπούλου</dc:creator>
  <dc:description/>
  <dc:language>en-US</dc:language>
  <cp:lastModifiedBy>Γιώργος Κουβατσέας</cp:lastModifiedBy>
  <dcterms:modified xsi:type="dcterms:W3CDTF">2013-12-05T08:08:15Z</dcterms:modified>
  <cp:revision>56</cp:revision>
  <dc:subject/>
  <dc:title>IGF in Adjuvant Breast Cancer</dc:title>
</cp:coreProperties>
</file>